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ppt/notesSlides/notesSlide9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13"/>
  </p:notesMasterIdLst>
  <p:sldIdLst>
    <p:sldId id="256" r:id="rId2"/>
    <p:sldId id="324" r:id="rId3"/>
    <p:sldId id="312" r:id="rId4"/>
    <p:sldId id="316" r:id="rId5"/>
    <p:sldId id="311" r:id="rId6"/>
    <p:sldId id="315" r:id="rId7"/>
    <p:sldId id="313" r:id="rId8"/>
    <p:sldId id="314" r:id="rId9"/>
    <p:sldId id="299" r:id="rId10"/>
    <p:sldId id="323" r:id="rId11"/>
    <p:sldId id="322" r:id="rId1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4169"/>
    <p:restoredTop sz="71571"/>
  </p:normalViewPr>
  <p:slideViewPr>
    <p:cSldViewPr snapToGrid="0" snapToObjects="1">
      <p:cViewPr varScale="1">
        <p:scale>
          <a:sx n="71" d="100"/>
          <a:sy n="71" d="100"/>
        </p:scale>
        <p:origin x="90" y="84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tableStyles" Target="tableStyles.xml"/><Relationship Id="rId2" Type="http://schemas.openxmlformats.org/officeDocument/2006/relationships/slide" Target="slides/slide1.xml"/><Relationship Id="rId16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viewProps" Target="viewProp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7564DE8-79AF-274C-A2E5-63B19E9DDC9E}" type="datetimeFigureOut">
              <a:rPr lang="en-US" smtClean="0"/>
              <a:t>7/30/2020</a:t>
            </a:fld>
            <a:endParaRPr lang="en-US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25B1064-C275-BF4F-AA71-0B8A34736C85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35466610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_rels/notesSlide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0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i="1" u="sng" dirty="0"/>
              <a:t>Facilitator’s Guide: </a:t>
            </a:r>
          </a:p>
          <a:p>
            <a:endParaRPr lang="en-US" dirty="0"/>
          </a:p>
          <a:p>
            <a:r>
              <a:rPr lang="en-US" dirty="0"/>
              <a:t>Review learning objectives for this post sepsis sim didactic 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25B1064-C275-BF4F-AA71-0B8A34736C85}" type="slidenum">
              <a:rPr lang="en-US" smtClean="0"/>
              <a:t>2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539500691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i="1" u="sng" dirty="0"/>
              <a:t>Facilitator’s Guide: </a:t>
            </a:r>
          </a:p>
          <a:p>
            <a:endParaRPr lang="en-US" dirty="0"/>
          </a:p>
          <a:p>
            <a:r>
              <a:rPr lang="en-US" dirty="0"/>
              <a:t>Ask learners about the definitions and risk factors for septic abortion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25B1064-C275-BF4F-AA71-0B8A34736C85}" type="slidenum">
              <a:rPr lang="en-US" smtClean="0"/>
              <a:t>3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167130043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i="1" u="sng" dirty="0"/>
              <a:t>Facilitator’s Guide: </a:t>
            </a:r>
          </a:p>
          <a:p>
            <a:endParaRPr lang="en-US" dirty="0"/>
          </a:p>
          <a:p>
            <a:r>
              <a:rPr lang="en-US" dirty="0"/>
              <a:t>Review pathophysiology of septic abortion. Emphasize that this is a clinical diagnosis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25B1064-C275-BF4F-AA71-0B8A34736C85}" type="slidenum">
              <a:rPr lang="en-US" smtClean="0"/>
              <a:t>4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195825917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i="1" u="sng" dirty="0"/>
              <a:t>Facilitator’s Guide: </a:t>
            </a:r>
          </a:p>
          <a:p>
            <a:endParaRPr lang="en-US" dirty="0"/>
          </a:p>
          <a:p>
            <a:r>
              <a:rPr lang="en-US" dirty="0"/>
              <a:t>Discuss with participants </a:t>
            </a:r>
          </a:p>
          <a:p>
            <a:pPr marL="171450" indent="-171450">
              <a:buFontTx/>
              <a:buChar char="-"/>
            </a:pPr>
            <a:r>
              <a:rPr lang="en-US" dirty="0"/>
              <a:t>the importance of prompt recognition of sepsis</a:t>
            </a:r>
          </a:p>
          <a:p>
            <a:pPr marL="628650" lvl="1" indent="-171450">
              <a:buFontTx/>
              <a:buChar char="-"/>
            </a:pPr>
            <a:r>
              <a:rPr lang="en-US" dirty="0"/>
              <a:t>ASK How do you diagnose? </a:t>
            </a:r>
          </a:p>
          <a:p>
            <a:pPr marL="1085850" lvl="2" indent="-171450">
              <a:buFontTx/>
              <a:buChar char="-"/>
            </a:pPr>
            <a:r>
              <a:rPr lang="en-US" dirty="0"/>
              <a:t>Ultrasound</a:t>
            </a:r>
          </a:p>
          <a:p>
            <a:pPr marL="1085850" lvl="2" indent="-171450">
              <a:buFontTx/>
              <a:buChar char="-"/>
            </a:pPr>
            <a:r>
              <a:rPr lang="en-US" dirty="0"/>
              <a:t>Physical exam</a:t>
            </a:r>
          </a:p>
          <a:p>
            <a:pPr marL="1085850" lvl="2" indent="-171450">
              <a:buFontTx/>
              <a:buChar char="-"/>
            </a:pPr>
            <a:r>
              <a:rPr lang="en-US" dirty="0"/>
              <a:t>Imaging</a:t>
            </a:r>
          </a:p>
          <a:p>
            <a:pPr marL="1085850" lvl="2" indent="-171450">
              <a:buFontTx/>
              <a:buChar char="-"/>
            </a:pPr>
            <a:r>
              <a:rPr lang="en-US" dirty="0"/>
              <a:t>Labs </a:t>
            </a:r>
          </a:p>
          <a:p>
            <a:pPr marL="0" indent="0">
              <a:buFontTx/>
              <a:buNone/>
            </a:pPr>
            <a:r>
              <a:rPr lang="en-US" dirty="0"/>
              <a:t>Review treatment</a:t>
            </a:r>
          </a:p>
          <a:p>
            <a:pPr marL="0" indent="0">
              <a:buFontTx/>
              <a:buNone/>
            </a:pPr>
            <a:r>
              <a:rPr lang="en-US" dirty="0"/>
              <a:t>-  Prompt re- aspiration</a:t>
            </a:r>
          </a:p>
          <a:p>
            <a:pPr marL="171450" indent="-171450">
              <a:buFontTx/>
              <a:buChar char="-"/>
            </a:pPr>
            <a:r>
              <a:rPr lang="en-US" dirty="0"/>
              <a:t>treatment with initiation of IV antibiotics</a:t>
            </a:r>
          </a:p>
          <a:p>
            <a:pPr marL="171450" indent="-171450">
              <a:buFontTx/>
              <a:buChar char="-"/>
            </a:pPr>
            <a:r>
              <a:rPr lang="en-US" dirty="0"/>
              <a:t>fluid resuscitation. 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25B1064-C275-BF4F-AA71-0B8A34736C85}" type="slidenum">
              <a:rPr lang="en-US" smtClean="0"/>
              <a:t>5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993499527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i="1" u="sng" dirty="0"/>
              <a:t>Facilitator’s Guide: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i="1" dirty="0"/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b="1" i="1" dirty="0"/>
              <a:t>This is a rendering of retained POC that should prompt participants to considering re-aspiration as part of treatment</a:t>
            </a:r>
          </a:p>
          <a:p>
            <a:endParaRPr lang="en-US" dirty="0"/>
          </a:p>
          <a:p>
            <a:r>
              <a:rPr lang="en-US" dirty="0"/>
              <a:t>Review other imaging modalities: </a:t>
            </a:r>
          </a:p>
          <a:p>
            <a:r>
              <a:rPr lang="en-US" dirty="0"/>
              <a:t>- Consider CT to look for gas outside the uterus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25B1064-C275-BF4F-AA71-0B8A34736C85}" type="slidenum">
              <a:rPr lang="en-US" smtClean="0"/>
              <a:t>6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754793626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i="1" u="sng" dirty="0"/>
              <a:t>Facilitator’s Guide: </a:t>
            </a:r>
          </a:p>
          <a:p>
            <a:endParaRPr lang="en-US" dirty="0"/>
          </a:p>
          <a:p>
            <a:r>
              <a:rPr lang="en-US" dirty="0"/>
              <a:t>Review the three most common microbes seen in septic abortions, understanding the microbes will help learners to recall the correct antibiotics 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25B1064-C275-BF4F-AA71-0B8A34736C85}" type="slidenum">
              <a:rPr lang="en-US" smtClean="0"/>
              <a:t>7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758894937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i="1" u="sng" dirty="0"/>
              <a:t>Facilitator’s Guide: </a:t>
            </a:r>
          </a:p>
          <a:p>
            <a:r>
              <a:rPr lang="en-US" dirty="0"/>
              <a:t>Review another diagnosis on the differential for a patient presenting with signs of infection after an abortion. </a:t>
            </a:r>
          </a:p>
          <a:p>
            <a:r>
              <a:rPr lang="en-US" dirty="0"/>
              <a:t>Post-abortion endometritis is more common (though still unusual) than sepsis and treated with the same guidelines as PID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25B1064-C275-BF4F-AA71-0B8A34736C85}" type="slidenum">
              <a:rPr lang="en-US" smtClean="0"/>
              <a:t>8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022348388"/>
      </p:ext>
    </p:extLst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i="1" u="sng" dirty="0"/>
              <a:t>Facilitator’s Guide: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i="1" dirty="0"/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i="1" dirty="0"/>
              <a:t>At this point in the presentation it is useful to have your Emergency Medicine colleagues discuss sepsis with the learners.</a:t>
            </a:r>
          </a:p>
          <a:p>
            <a:endParaRPr lang="en-US" dirty="0"/>
          </a:p>
          <a:p>
            <a:r>
              <a:rPr lang="en-US" dirty="0"/>
              <a:t>Review the surviving sepsis guidelines available online t</a:t>
            </a:r>
            <a:r>
              <a:rPr lang="en-US" dirty="0">
                <a:solidFill>
                  <a:schemeClr val="tx1"/>
                </a:solidFill>
              </a:rPr>
              <a:t>o review definitions, diagnosis, and management of sepsis:</a:t>
            </a:r>
          </a:p>
          <a:p>
            <a:r>
              <a:rPr lang="en-US" dirty="0">
                <a:solidFill>
                  <a:schemeClr val="tx1"/>
                </a:solidFill>
              </a:rPr>
              <a:t>2016 Surviving Sepsis Campaign Guidelines Presentation, available via The Society of Critical Care Medicine at: survivingsepsis.org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25B1064-C275-BF4F-AA71-0B8A34736C85}" type="slidenum">
              <a:rPr lang="en-US" smtClean="0"/>
              <a:t>9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839371381"/>
      </p:ext>
    </p:extLst>
  </p:cSld>
  <p:clrMapOvr>
    <a:masterClrMapping/>
  </p:clrMapOvr>
</p:notes>
</file>

<file path=ppt/notesSlides/notesSlide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i="1" dirty="0"/>
              <a:t>Facilitator’s Guide: </a:t>
            </a:r>
          </a:p>
          <a:p>
            <a:r>
              <a:rPr lang="en-US" i="0" dirty="0"/>
              <a:t>You can review institution specific guidelines/protocols for managing sepsis here.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25B1064-C275-BF4F-AA71-0B8A34736C85}" type="slidenum">
              <a:rPr lang="en-US" smtClean="0"/>
              <a:t>10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90626393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9BABDE0-5CAD-E74C-9258-5BEDDCB5E8D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4B0EE53F-1E24-D546-B293-3F5CBFFB812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5C472A3-FBAB-B445-A03D-BF05AE5BC5A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ADD99D-31E8-3E4C-B1CE-3CBCCFA248A5}" type="datetimeFigureOut">
              <a:rPr lang="en-US" smtClean="0"/>
              <a:t>7/30/2020</a:t>
            </a:fld>
            <a:endParaRPr lang="en-US" dirty="0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95BA2B9-9DC3-8244-92A2-6B3215EB0D0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F3F6BE8-6960-6E47-889E-1E6FFD307CA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C58AF2-6A24-4449-A87A-CBA1658F88E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91167831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B8621A4-43E3-B448-8F7E-36CB0A78035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96BA7A9-8318-9440-9B2C-EC0CB671F1C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84C9552-E82F-DE43-ABC5-72EA130B62C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ADD99D-31E8-3E4C-B1CE-3CBCCFA248A5}" type="datetimeFigureOut">
              <a:rPr lang="en-US" smtClean="0"/>
              <a:t>7/30/2020</a:t>
            </a:fld>
            <a:endParaRPr lang="en-US" dirty="0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8DCF55B-E100-E642-8D78-1B34235B4BF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F3BEC73-A3A2-E149-86FE-9B418470E2C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C58AF2-6A24-4449-A87A-CBA1658F88E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93122496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5AE6DD55-DE53-9B41-BB12-602C0FBAA98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ECB7542-6112-B643-8B84-F6C6E5B5204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6E3361C-7E8E-E242-BE76-71805012305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ADD99D-31E8-3E4C-B1CE-3CBCCFA248A5}" type="datetimeFigureOut">
              <a:rPr lang="en-US" smtClean="0"/>
              <a:t>7/30/2020</a:t>
            </a:fld>
            <a:endParaRPr lang="en-US" dirty="0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888F81C-D5C9-2745-A3D1-092BAC3D42B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D1F56E2-1F39-D547-B6FE-16A40A9F55B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C58AF2-6A24-4449-A87A-CBA1658F88E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62207723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D53CD27-6060-4241-B3F6-E459BA2752C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E29C0EF-B7CE-544A-98EA-88687CFCF10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AB81C6F-62A8-8F48-9A0E-E500550A9C5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ADD99D-31E8-3E4C-B1CE-3CBCCFA248A5}" type="datetimeFigureOut">
              <a:rPr lang="en-US" smtClean="0"/>
              <a:t>7/30/2020</a:t>
            </a:fld>
            <a:endParaRPr lang="en-US" dirty="0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0C2037C-4020-C94A-9A70-A4A7F22D0B9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0F79961-9FD9-0A45-8810-67AD1993D90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C58AF2-6A24-4449-A87A-CBA1658F88E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12827608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F9B912D-5099-BF40-A2AA-47D3601871E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9395B4F-4E9F-E845-A710-700548F2A9F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684A6F5-3AEF-D64C-8AC2-F15D5DE7AD7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ADD99D-31E8-3E4C-B1CE-3CBCCFA248A5}" type="datetimeFigureOut">
              <a:rPr lang="en-US" smtClean="0"/>
              <a:t>7/30/2020</a:t>
            </a:fld>
            <a:endParaRPr lang="en-US" dirty="0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F6C9182-D0EE-DD40-9B45-F84D16FFD4D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9D8B1F9-FB58-4D4B-8989-DB388F7671C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C58AF2-6A24-4449-A87A-CBA1658F88E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78287891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B7A7454-7CB6-8241-A24E-CBA3FFF0CB4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1AFEB10-0A8C-EB46-BA79-CCBB9F06057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C016C81-AD63-E54E-9EC1-48897F2C31D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92C6F80-5FBB-7E4C-8E4B-2FD2573DE79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ADD99D-31E8-3E4C-B1CE-3CBCCFA248A5}" type="datetimeFigureOut">
              <a:rPr lang="en-US" smtClean="0"/>
              <a:t>7/30/2020</a:t>
            </a:fld>
            <a:endParaRPr lang="en-US" dirty="0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028D34E-BAF3-A74F-8019-63EE46FCDBF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1EA89FC-C667-6E40-8F99-99B35360A79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C58AF2-6A24-4449-A87A-CBA1658F88E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26367766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1B08BF4-79C3-7B42-A342-B413C71CD98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4B3211F-77C7-3F49-8CE3-3F9B587F7BB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04E3C34-18B9-2A4B-9242-42F627CE4A4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8186D6B3-9804-5543-A86E-AA904FC5FD0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57CEA265-6D34-4145-9DD5-04546C38226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6CB788CF-3D11-F242-BD13-1A90C89C00C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ADD99D-31E8-3E4C-B1CE-3CBCCFA248A5}" type="datetimeFigureOut">
              <a:rPr lang="en-US" smtClean="0"/>
              <a:t>7/30/2020</a:t>
            </a:fld>
            <a:endParaRPr lang="en-US" dirty="0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F1218192-D863-5248-B18E-A1692FD9DE8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95A4486A-7ED2-004C-9900-5A1F6E377A1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C58AF2-6A24-4449-A87A-CBA1658F88E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59224143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A02A281-A065-2848-9F07-16F4A4C6C3E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0D86976F-350D-8B42-A76D-3E8F6C1C61E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ADD99D-31E8-3E4C-B1CE-3CBCCFA248A5}" type="datetimeFigureOut">
              <a:rPr lang="en-US" smtClean="0"/>
              <a:t>7/30/2020</a:t>
            </a:fld>
            <a:endParaRPr lang="en-US" dirty="0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0771AF95-577C-D645-8119-93A3B803CFA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A75C00BF-7334-E648-AEA5-D7D52DFDA8D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C58AF2-6A24-4449-A87A-CBA1658F88E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21698068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EC1DCDB8-2F30-484A-B58C-46A12B2CFDE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ADD99D-31E8-3E4C-B1CE-3CBCCFA248A5}" type="datetimeFigureOut">
              <a:rPr lang="en-US" smtClean="0"/>
              <a:t>7/30/2020</a:t>
            </a:fld>
            <a:endParaRPr lang="en-US" dirty="0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0FDE0334-3886-4F43-97A4-5B0158FDE2F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14AF1092-2CEC-3149-8E73-31AD0DF5E92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C58AF2-6A24-4449-A87A-CBA1658F88E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99234107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559700E-5682-9041-9F51-CF30C04A309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8CE259A-FF1D-E342-9210-E66D63807CA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9EB6937-17CE-E847-908A-542DDA7770F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3650BD6-E975-3E4D-BD07-99A46084DBD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ADD99D-31E8-3E4C-B1CE-3CBCCFA248A5}" type="datetimeFigureOut">
              <a:rPr lang="en-US" smtClean="0"/>
              <a:t>7/30/2020</a:t>
            </a:fld>
            <a:endParaRPr lang="en-US" dirty="0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07E52ED-E97E-0A4F-A2FF-B72158711D7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4B86260-165F-D24B-B991-C3E9AAC667C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C58AF2-6A24-4449-A87A-CBA1658F88E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68576402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4C68572-5ED8-F343-A968-1BB9F9B59B1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669F55FE-04EC-2143-A6ED-FA69CC9E662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 dirty="0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D7BB214-2EFC-5948-88AE-3F8080988FD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CDDCECD-BF1E-CD49-8759-C027163FC3C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ADD99D-31E8-3E4C-B1CE-3CBCCFA248A5}" type="datetimeFigureOut">
              <a:rPr lang="en-US" smtClean="0"/>
              <a:t>7/30/2020</a:t>
            </a:fld>
            <a:endParaRPr lang="en-US" dirty="0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2631459-493B-0A49-AB9F-0A67D34B585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8D313E9-D3C8-4D4E-8F25-4999DF4BA76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C58AF2-6A24-4449-A87A-CBA1658F88E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07282171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AB606C63-7DA1-3E42-B8EC-685A0C45D78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8DD7A99-1179-4142-BB9B-5DE71841186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4F3E05A-C961-064A-9853-71BB306FBD1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AADD99D-31E8-3E4C-B1CE-3CBCCFA248A5}" type="datetimeFigureOut">
              <a:rPr lang="en-US" smtClean="0"/>
              <a:t>7/30/2020</a:t>
            </a:fld>
            <a:endParaRPr lang="en-US" dirty="0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FDB6976-2257-DE48-932E-891F1410EDB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 dirty="0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441A2C7-091C-3542-A816-DDD3947D69E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8C58AF2-6A24-4449-A87A-CBA1658F88E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91575298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9.xml"/><Relationship Id="rId1" Type="http://schemas.openxmlformats.org/officeDocument/2006/relationships/slideLayout" Target="../slideLayouts/slideLayout3.xml"/></Relationships>
</file>

<file path=ppt/slides/_rels/slide1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hyperlink" Target="https://www.glowm.com/section_view/heading/Septic%20Abortion:%20Prevention%20and%20Management/item/437" TargetMode="External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hyperlink" Target="https://www.glowm.com/section_view/heading/Septic%20Abortion:%20Prevention%20and%20Management/item/437" TargetMode="External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8.xml"/><Relationship Id="rId1" Type="http://schemas.openxmlformats.org/officeDocument/2006/relationships/slideLayout" Target="../slideLayouts/slideLayou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4665CD6-0A1F-8E47-8ECD-0EE692A720D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2"/>
            <a:ext cx="9144000" cy="2771211"/>
          </a:xfrm>
        </p:spPr>
        <p:txBody>
          <a:bodyPr/>
          <a:lstStyle/>
          <a:p>
            <a:r>
              <a:rPr lang="en-US" dirty="0"/>
              <a:t>Family Planning Simulation:</a:t>
            </a:r>
            <a:br>
              <a:rPr lang="en-US" dirty="0"/>
            </a:br>
            <a:r>
              <a:rPr lang="en-US" dirty="0"/>
              <a:t>Sepsis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C926C106-3B74-5F4B-BE49-E251AAF1923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4429919"/>
            <a:ext cx="9144000" cy="1655762"/>
          </a:xfrm>
        </p:spPr>
        <p:txBody>
          <a:bodyPr/>
          <a:lstStyle/>
          <a:p>
            <a:r>
              <a:rPr lang="en-US" i="1" dirty="0"/>
              <a:t>Date</a:t>
            </a:r>
          </a:p>
        </p:txBody>
      </p:sp>
    </p:spTree>
    <p:extLst>
      <p:ext uri="{BB962C8B-B14F-4D97-AF65-F5344CB8AC3E}">
        <p14:creationId xmlns:p14="http://schemas.microsoft.com/office/powerpoint/2010/main" val="1327408221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>
            <a:extLst>
              <a:ext uri="{FF2B5EF4-FFF2-40B4-BE49-F238E27FC236}">
                <a16:creationId xmlns:a16="http://schemas.microsoft.com/office/drawing/2014/main" id="{4C16A1D6-0CF5-C14A-A7A3-D662B3C353F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Review Institutional Sepsis Protocols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1EED38B-60F3-A24F-B1D3-7BD3DE78FF16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367622615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Questions???</a:t>
            </a:r>
          </a:p>
        </p:txBody>
      </p:sp>
    </p:spTree>
    <p:extLst>
      <p:ext uri="{BB962C8B-B14F-4D97-AF65-F5344CB8AC3E}">
        <p14:creationId xmlns:p14="http://schemas.microsoft.com/office/powerpoint/2010/main" val="149292990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5E70F50-239F-D94B-94E5-C95C54A8CBC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Learning Objectives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9756EAA-B43B-FB48-AA6F-BC824A6E733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dirty="0"/>
              <a:t>Review diagnosis of sepsis in a patient after an abortion</a:t>
            </a:r>
            <a:endParaRPr lang="en-US" b="1" dirty="0"/>
          </a:p>
          <a:p>
            <a:pPr lvl="0"/>
            <a:r>
              <a:rPr lang="en-US" dirty="0"/>
              <a:t>Describe the differential diagnosis of sepsis following abortion</a:t>
            </a:r>
            <a:endParaRPr lang="en-US" b="1" dirty="0"/>
          </a:p>
          <a:p>
            <a:r>
              <a:rPr lang="en-US" dirty="0"/>
              <a:t>Develop a plan to evaluate and manage the most common etiologies of sepsis as a first-trimester abortion complications </a:t>
            </a:r>
          </a:p>
        </p:txBody>
      </p:sp>
    </p:spTree>
    <p:extLst>
      <p:ext uri="{BB962C8B-B14F-4D97-AF65-F5344CB8AC3E}">
        <p14:creationId xmlns:p14="http://schemas.microsoft.com/office/powerpoint/2010/main" val="198278940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553EF1E-3C6A-574E-AEA0-AF643763426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Septic Abortion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2DCFDC3-9CB1-D046-8152-455F9B49099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>
            <a:normAutofit/>
          </a:bodyPr>
          <a:lstStyle/>
          <a:p>
            <a:pPr marL="0" indent="0">
              <a:buNone/>
            </a:pPr>
            <a:r>
              <a:rPr lang="en-US" dirty="0"/>
              <a:t>Definition</a:t>
            </a:r>
          </a:p>
          <a:p>
            <a:pPr lvl="1"/>
            <a:r>
              <a:rPr lang="en-US" dirty="0"/>
              <a:t>Abortion complicated by fever, endometritis, parametritis</a:t>
            </a:r>
          </a:p>
          <a:p>
            <a:pPr lvl="1"/>
            <a:r>
              <a:rPr lang="en-US" dirty="0"/>
              <a:t>Serious threat to women’s health world wide </a:t>
            </a:r>
          </a:p>
          <a:p>
            <a:pPr lvl="1"/>
            <a:r>
              <a:rPr lang="en-US" dirty="0"/>
              <a:t>Rare in countries with legal abortion </a:t>
            </a:r>
          </a:p>
          <a:p>
            <a:pPr lvl="1"/>
            <a:endParaRPr lang="en-US" dirty="0"/>
          </a:p>
          <a:p>
            <a:r>
              <a:rPr lang="en-US" dirty="0"/>
              <a:t>Risk Factors </a:t>
            </a:r>
          </a:p>
          <a:p>
            <a:pPr lvl="1"/>
            <a:r>
              <a:rPr lang="en-US" dirty="0"/>
              <a:t>Aspiration abortion </a:t>
            </a:r>
          </a:p>
          <a:p>
            <a:pPr lvl="1"/>
            <a:r>
              <a:rPr lang="en-US" dirty="0"/>
              <a:t>Cervicitis - gonorrhea or chlamydia</a:t>
            </a:r>
          </a:p>
          <a:p>
            <a:pPr lvl="1"/>
            <a:r>
              <a:rPr lang="en-US" dirty="0"/>
              <a:t>Possibly vaginal misoprostol for medication abortion</a:t>
            </a:r>
          </a:p>
          <a:p>
            <a:pPr lvl="1"/>
            <a:r>
              <a:rPr lang="en-US" dirty="0"/>
              <a:t>Unsafe abortion</a:t>
            </a:r>
          </a:p>
          <a:p>
            <a:pPr lvl="1"/>
            <a:endParaRPr lang="en-US" dirty="0"/>
          </a:p>
          <a:p>
            <a:pPr marL="0" indent="0">
              <a:buNone/>
            </a:pPr>
            <a:endParaRPr lang="en-US" dirty="0"/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BEE59501-AA6B-C540-87E7-6049B85BA1B7}"/>
              </a:ext>
            </a:extLst>
          </p:cNvPr>
          <p:cNvSpPr txBox="1"/>
          <p:nvPr/>
        </p:nvSpPr>
        <p:spPr>
          <a:xfrm>
            <a:off x="617220" y="6377940"/>
            <a:ext cx="1122426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hlinkClick r:id="rId3"/>
              </a:rPr>
              <a:t>https://www.glowm.com/section_view/heading/Septic%20Abortion:%20Prevention%20and%20Management/item/437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377014524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6A40F6D-1EA2-9A48-A9D4-76E37CDDE2A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Septic Abortion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849809F-DA67-1A4F-9262-0525B1C6CDE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0" indent="0">
              <a:buNone/>
            </a:pPr>
            <a:r>
              <a:rPr lang="en-US" dirty="0"/>
              <a:t>Pathophysiology</a:t>
            </a:r>
          </a:p>
          <a:p>
            <a:pPr lvl="1"/>
            <a:r>
              <a:rPr lang="en-US" dirty="0"/>
              <a:t>Retained POC</a:t>
            </a:r>
          </a:p>
          <a:p>
            <a:pPr lvl="1"/>
            <a:r>
              <a:rPr lang="en-US" dirty="0"/>
              <a:t>Ascending infection</a:t>
            </a:r>
          </a:p>
          <a:p>
            <a:pPr lvl="1"/>
            <a:r>
              <a:rPr lang="en-US" dirty="0"/>
              <a:t>Improper or unsafe technique</a:t>
            </a:r>
          </a:p>
          <a:p>
            <a:pPr marL="457200" lvl="1" indent="0">
              <a:buNone/>
            </a:pPr>
            <a:endParaRPr lang="en-US" dirty="0"/>
          </a:p>
          <a:p>
            <a:r>
              <a:rPr lang="en-US" dirty="0"/>
              <a:t>Diagnosis</a:t>
            </a:r>
          </a:p>
          <a:p>
            <a:pPr lvl="1"/>
            <a:r>
              <a:rPr lang="en-US" dirty="0"/>
              <a:t>Made clinically, aided by imaging 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11533082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486B99A-F052-8745-A84D-71F64CCF799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Septic abortion 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CBBDA9C-347D-E04F-BAB4-A42402C1E89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>
            <a:normAutofit fontScale="92500" lnSpcReduction="20000"/>
          </a:bodyPr>
          <a:lstStyle/>
          <a:p>
            <a:pPr marL="0" indent="0">
              <a:buNone/>
            </a:pPr>
            <a:r>
              <a:rPr lang="en-US" dirty="0"/>
              <a:t>Prevention of Morbidity and Mortality </a:t>
            </a:r>
          </a:p>
          <a:p>
            <a:pPr lvl="1"/>
            <a:r>
              <a:rPr lang="en-US" dirty="0"/>
              <a:t>Prompt detection and treatment </a:t>
            </a:r>
          </a:p>
          <a:p>
            <a:pPr lvl="2"/>
            <a:r>
              <a:rPr lang="en-US" dirty="0"/>
              <a:t>Delay in diagnosis contributes to mortality </a:t>
            </a:r>
          </a:p>
          <a:p>
            <a:pPr lvl="1"/>
            <a:r>
              <a:rPr lang="en-US" dirty="0"/>
              <a:t>Obtain information about the abortion</a:t>
            </a:r>
          </a:p>
          <a:p>
            <a:pPr lvl="1"/>
            <a:r>
              <a:rPr lang="en-US" dirty="0"/>
              <a:t>Physical exam to evaluate vagina, cervix, uterus</a:t>
            </a:r>
          </a:p>
          <a:p>
            <a:pPr lvl="1"/>
            <a:r>
              <a:rPr lang="en-US" dirty="0"/>
              <a:t>Imaging</a:t>
            </a:r>
          </a:p>
          <a:p>
            <a:pPr lvl="1"/>
            <a:r>
              <a:rPr lang="en-US" dirty="0"/>
              <a:t>Labs including blood cultures, vaginal and cervical cultures</a:t>
            </a:r>
          </a:p>
          <a:p>
            <a:pPr marL="457200" lvl="1" indent="0">
              <a:buNone/>
            </a:pPr>
            <a:endParaRPr lang="en-US" dirty="0"/>
          </a:p>
          <a:p>
            <a:pPr marL="0" indent="0">
              <a:buNone/>
            </a:pPr>
            <a:r>
              <a:rPr lang="en-US" dirty="0"/>
              <a:t>Treatment</a:t>
            </a:r>
          </a:p>
          <a:p>
            <a:pPr lvl="1"/>
            <a:r>
              <a:rPr lang="en-US" dirty="0"/>
              <a:t>IV antibiotics</a:t>
            </a:r>
          </a:p>
          <a:p>
            <a:pPr lvl="1"/>
            <a:r>
              <a:rPr lang="en-US" dirty="0"/>
              <a:t>IV fluid resuscitation</a:t>
            </a:r>
          </a:p>
          <a:p>
            <a:pPr lvl="1"/>
            <a:r>
              <a:rPr lang="en-US" dirty="0"/>
              <a:t>Re-aspiration</a:t>
            </a:r>
          </a:p>
          <a:p>
            <a:pPr lvl="2"/>
            <a:r>
              <a:rPr lang="en-US" dirty="0"/>
              <a:t>At bedside with local anesthesia vs. OR </a:t>
            </a:r>
          </a:p>
          <a:p>
            <a:pPr marL="457200" lvl="1" indent="0">
              <a:buNone/>
            </a:pPr>
            <a:endParaRPr lang="en-US" dirty="0"/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7C99349C-2D50-844B-BD06-5E90328F7D8E}"/>
              </a:ext>
            </a:extLst>
          </p:cNvPr>
          <p:cNvSpPr txBox="1"/>
          <p:nvPr/>
        </p:nvSpPr>
        <p:spPr>
          <a:xfrm>
            <a:off x="617220" y="6377940"/>
            <a:ext cx="1122426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hlinkClick r:id="rId3"/>
              </a:rPr>
              <a:t>https://www.glowm.com/section_view/heading/Septic%20Abortion:%20Prevention%20and%20Management/item/437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3368882207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FCA4902-E3D8-BA4E-AB90-3785DCEE80D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Imaging: TVUS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1385A426-D297-4A49-89F3-5C91FE5213FD}"/>
              </a:ext>
            </a:extLst>
          </p:cNvPr>
          <p:cNvSpPr txBox="1"/>
          <p:nvPr/>
        </p:nvSpPr>
        <p:spPr>
          <a:xfrm>
            <a:off x="647700" y="6159500"/>
            <a:ext cx="611507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+mj-lt"/>
              </a:rPr>
              <a:t>May also consider ordering a CT to look for free air in the pelvis</a:t>
            </a:r>
          </a:p>
          <a:p>
            <a:endParaRPr lang="en-US" dirty="0">
              <a:latin typeface="+mj-lt"/>
            </a:endParaRP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A8CC4922-D622-6D47-9D3D-355EE12F283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dirty="0"/>
              <a:t>Retained products 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4671D9D7-5F5F-7146-9AB3-5A439B9700E5}"/>
              </a:ext>
            </a:extLst>
          </p:cNvPr>
          <p:cNvSpPr txBox="1"/>
          <p:nvPr/>
        </p:nvSpPr>
        <p:spPr>
          <a:xfrm>
            <a:off x="5712858" y="5601962"/>
            <a:ext cx="159601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uthor owned.</a:t>
            </a: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0FF82375-B893-F64A-95AD-B531E7AD15DF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18066" t="9200" r="17916" b="23200"/>
          <a:stretch/>
        </p:blipFill>
        <p:spPr>
          <a:xfrm>
            <a:off x="5712858" y="1300997"/>
            <a:ext cx="5422900" cy="4292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435792698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3A64B89-6AC8-7C47-B327-3F8846806A0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Microbes 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18F9475-11CC-3048-A218-98AD66063DF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dirty="0"/>
              <a:t>Polymicrobial – Vaginal flora possibly sexually transmitted organisms</a:t>
            </a:r>
          </a:p>
          <a:p>
            <a:pPr lvl="1"/>
            <a:r>
              <a:rPr lang="en-US" dirty="0"/>
              <a:t>ABX: amp/gent/clinda</a:t>
            </a:r>
          </a:p>
          <a:p>
            <a:r>
              <a:rPr lang="en-US" dirty="0"/>
              <a:t>Clostridium sordellii</a:t>
            </a:r>
          </a:p>
          <a:p>
            <a:pPr lvl="1"/>
            <a:r>
              <a:rPr lang="en-US" dirty="0"/>
              <a:t>Seen in a small number of women after medication abortion with mifepristone and vaginal misoprostol </a:t>
            </a:r>
          </a:p>
          <a:p>
            <a:pPr lvl="1"/>
            <a:r>
              <a:rPr lang="en-US" dirty="0"/>
              <a:t>Presents with high leukemoid reaction (WBC &gt;50K)and hemoconcentration </a:t>
            </a:r>
          </a:p>
          <a:p>
            <a:pPr lvl="1"/>
            <a:r>
              <a:rPr lang="en-US" dirty="0"/>
              <a:t>ABX: vanc/</a:t>
            </a:r>
            <a:r>
              <a:rPr lang="en-US" dirty="0" err="1"/>
              <a:t>clinda</a:t>
            </a:r>
            <a:r>
              <a:rPr lang="en-US" dirty="0"/>
              <a:t>/piperacillin/tazobactam</a:t>
            </a:r>
          </a:p>
          <a:p>
            <a:r>
              <a:rPr lang="en-US" dirty="0"/>
              <a:t>Group A Strep</a:t>
            </a:r>
          </a:p>
          <a:p>
            <a:pPr lvl="1"/>
            <a:r>
              <a:rPr lang="en-US" dirty="0"/>
              <a:t>ABX: vanc/</a:t>
            </a:r>
            <a:r>
              <a:rPr lang="en-US" dirty="0" err="1"/>
              <a:t>clinda</a:t>
            </a:r>
            <a:r>
              <a:rPr lang="en-US"/>
              <a:t>/piperacillin/tazobactam</a:t>
            </a:r>
            <a:endParaRPr lang="en-US" dirty="0"/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3E430184-A05A-3D4F-8264-AD3056F37E13}"/>
              </a:ext>
            </a:extLst>
          </p:cNvPr>
          <p:cNvSpPr txBox="1"/>
          <p:nvPr/>
        </p:nvSpPr>
        <p:spPr>
          <a:xfrm>
            <a:off x="586740" y="6176963"/>
            <a:ext cx="915162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/>
              <a:t>Fischer, M et al. Fatal Toxic Shock Syndrome Associated with Clostridium sordellii after Medical Abortion.  N Engl J Med 2005; 353:2352-60.</a:t>
            </a:r>
          </a:p>
        </p:txBody>
      </p:sp>
    </p:spTree>
    <p:extLst>
      <p:ext uri="{BB962C8B-B14F-4D97-AF65-F5344CB8AC3E}">
        <p14:creationId xmlns:p14="http://schemas.microsoft.com/office/powerpoint/2010/main" val="1162792431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29D9B3F-4CC3-AA49-A0BE-E97DBAA6C75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Post abortion endometritis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208B098-72EE-FD47-A457-F8D757DE412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dirty="0"/>
              <a:t>Infection after abortion without sepsis</a:t>
            </a:r>
          </a:p>
          <a:p>
            <a:pPr lvl="1"/>
            <a:r>
              <a:rPr lang="en-US" dirty="0"/>
              <a:t>Occurs in approximately 1% or less of all abortions</a:t>
            </a:r>
          </a:p>
          <a:p>
            <a:r>
              <a:rPr lang="en-US" dirty="0"/>
              <a:t>Use CDC recommendations for treatment of PID</a:t>
            </a:r>
          </a:p>
          <a:p>
            <a:pPr lvl="1"/>
            <a:r>
              <a:rPr lang="en-US" dirty="0"/>
              <a:t>Ceftriaxone/Doxy/Flagyl</a:t>
            </a:r>
          </a:p>
          <a:p>
            <a:pPr lvl="1"/>
            <a:endParaRPr lang="en-US" dirty="0"/>
          </a:p>
          <a:p>
            <a:r>
              <a:rPr lang="en-US" dirty="0"/>
              <a:t>Notably, in comparison to sepsis, this is a more frequent complication</a:t>
            </a:r>
          </a:p>
          <a:p>
            <a:pPr lvl="1"/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91589669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>
            <a:extLst>
              <a:ext uri="{FF2B5EF4-FFF2-40B4-BE49-F238E27FC236}">
                <a16:creationId xmlns:a16="http://schemas.microsoft.com/office/drawing/2014/main" id="{4C16A1D6-0CF5-C14A-A7A3-D662B3C353F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Surviving Sepsis Campaign 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118BB130-C006-4148-AAEC-7DDE1B3FA6DF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>
              <a:solidFill>
                <a:schemeClr val="tx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53235946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988</TotalTime>
  <Words>648</Words>
  <Application>Microsoft Office PowerPoint</Application>
  <PresentationFormat>Widescreen</PresentationFormat>
  <Paragraphs>116</Paragraphs>
  <Slides>11</Slides>
  <Notes>9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1</vt:i4>
      </vt:variant>
    </vt:vector>
  </HeadingPairs>
  <TitlesOfParts>
    <vt:vector size="15" baseType="lpstr">
      <vt:lpstr>Arial</vt:lpstr>
      <vt:lpstr>Calibri</vt:lpstr>
      <vt:lpstr>Calibri Light</vt:lpstr>
      <vt:lpstr>Office Theme</vt:lpstr>
      <vt:lpstr>Family Planning Simulation: Sepsis</vt:lpstr>
      <vt:lpstr>Learning Objectives</vt:lpstr>
      <vt:lpstr>Septic Abortion</vt:lpstr>
      <vt:lpstr>Septic Abortion</vt:lpstr>
      <vt:lpstr>Septic abortion </vt:lpstr>
      <vt:lpstr>Imaging: TVUS</vt:lpstr>
      <vt:lpstr>Microbes </vt:lpstr>
      <vt:lpstr>Post abortion endometritis</vt:lpstr>
      <vt:lpstr>Surviving Sepsis Campaign </vt:lpstr>
      <vt:lpstr>Review Institutional Sepsis Protocols</vt:lpstr>
      <vt:lpstr>Questions???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amily Planning Sim</dc:title>
  <dc:creator>Microsoft Office User</dc:creator>
  <cp:lastModifiedBy>Jonathan Oloughlin</cp:lastModifiedBy>
  <cp:revision>44</cp:revision>
  <dcterms:created xsi:type="dcterms:W3CDTF">2019-03-24T19:11:30Z</dcterms:created>
  <dcterms:modified xsi:type="dcterms:W3CDTF">2020-07-30T19:21:44Z</dcterms:modified>
</cp:coreProperties>
</file>